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4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1382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7513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0968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1083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7349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1385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9034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5686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617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2134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3711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6368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4" t="4197" r="7895" b="8642"/>
          <a:stretch/>
        </p:blipFill>
        <p:spPr>
          <a:xfrm>
            <a:off x="2272242" y="0"/>
            <a:ext cx="7281334" cy="597746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05025" y="6057900"/>
            <a:ext cx="83343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/>
              <a:t>Supplementary Figure 2. Average value of metabolites with standard deviation determined in Blood samples determined from CPMG experiment. Shown are values prior to normalization.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9925049" y="866775"/>
            <a:ext cx="2156731" cy="1723164"/>
            <a:chOff x="9925049" y="866775"/>
            <a:chExt cx="2156731" cy="1723164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/>
            <a:srcRect l="14083" t="18531" r="79909" b="79566"/>
            <a:stretch/>
          </p:blipFill>
          <p:spPr>
            <a:xfrm>
              <a:off x="9925049" y="933450"/>
              <a:ext cx="590551" cy="1905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14083" t="21862" r="79909" b="76045"/>
            <a:stretch/>
          </p:blipFill>
          <p:spPr>
            <a:xfrm>
              <a:off x="9925049" y="1142999"/>
              <a:ext cx="590551" cy="20955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/>
            <a:srcRect l="14083" t="25381" r="79909" b="72335"/>
            <a:stretch/>
          </p:blipFill>
          <p:spPr>
            <a:xfrm>
              <a:off x="9934574" y="1352551"/>
              <a:ext cx="590551" cy="2286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/>
            <a:srcRect l="14083" t="29092" r="79909" b="69005"/>
            <a:stretch/>
          </p:blipFill>
          <p:spPr>
            <a:xfrm>
              <a:off x="9934574" y="1581150"/>
              <a:ext cx="590551" cy="1905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/>
            <a:srcRect l="14083" t="32517" r="79909" b="65485"/>
            <a:stretch/>
          </p:blipFill>
          <p:spPr>
            <a:xfrm>
              <a:off x="9934574" y="1790700"/>
              <a:ext cx="590551" cy="200025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3"/>
            <a:srcRect l="14083" t="36132" r="79909" b="61965"/>
            <a:stretch/>
          </p:blipFill>
          <p:spPr>
            <a:xfrm>
              <a:off x="9944099" y="2000250"/>
              <a:ext cx="590551" cy="1905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/>
            <a:srcRect l="14083" t="39652" r="79909" b="58350"/>
            <a:stretch/>
          </p:blipFill>
          <p:spPr>
            <a:xfrm>
              <a:off x="9944099" y="2181225"/>
              <a:ext cx="590551" cy="200026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/>
            <a:srcRect l="14083" t="43268" r="79909" b="54829"/>
            <a:stretch/>
          </p:blipFill>
          <p:spPr>
            <a:xfrm>
              <a:off x="9944099" y="2371725"/>
              <a:ext cx="590551" cy="190498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0458450" y="866775"/>
              <a:ext cx="1623330" cy="1723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600"/>
                </a:lnSpc>
              </a:pPr>
              <a:r>
                <a:rPr lang="en-CA" sz="1200" dirty="0"/>
                <a:t>Male, control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APP2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control, 7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APP2, 7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control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APP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control, 9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APP, 9mnt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24736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4</TotalTime>
  <Words>67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RC-CN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perlovic-Culf, Miroslava</dc:creator>
  <cp:lastModifiedBy>HYD OFF33</cp:lastModifiedBy>
  <cp:revision>5</cp:revision>
  <dcterms:created xsi:type="dcterms:W3CDTF">2021-03-17T15:38:07Z</dcterms:created>
  <dcterms:modified xsi:type="dcterms:W3CDTF">2021-04-23T02:41:33Z</dcterms:modified>
</cp:coreProperties>
</file>